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60" r:id="rId5"/>
    <p:sldId id="261" r:id="rId6"/>
    <p:sldId id="259" r:id="rId7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2268" y="1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065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3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790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222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661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455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9588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17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21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643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769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FD902-D712-411C-BB11-EF74CBB66F98}" type="datetimeFigureOut">
              <a:rPr lang="en-US" smtClean="0"/>
              <a:pPr/>
              <a:t>11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72FD8-E00E-4F6C-8F06-A631A96B3F3C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994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476672" y="25152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188640" y="6876256"/>
            <a:ext cx="63093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sessmen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efflux activity by real-tim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uorometr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OC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fflux assay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K1758 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SA1199 (wild type), and SA1199B (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A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++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th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thout (=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 no EPI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Real-tim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orometri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ssays were conducted in the presence of 56.2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lucos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ach curve represents the mean of three independent experiments. </a:t>
            </a:r>
          </a:p>
        </p:txBody>
      </p:sp>
      <p:pic>
        <p:nvPicPr>
          <p:cNvPr id="2" name="Picture 2" descr="C:\Users\L00527\Desktop\proyecto nuevo\papers\Saskia\Paper antimicrobials\Re submission to frontiers\resubmission\efflux pump assay with wt ko and overexpressed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24" y="1294070"/>
            <a:ext cx="6813376" cy="44359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64141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80" y="971600"/>
            <a:ext cx="5605758" cy="29400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feld 8"/>
          <p:cNvSpPr txBox="1"/>
          <p:nvPr/>
        </p:nvSpPr>
        <p:spPr>
          <a:xfrm>
            <a:off x="476672" y="25152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88640" y="6876256"/>
            <a:ext cx="63093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effect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rial concentrations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iprofloxac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fil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vention (BPC) and eradication (BE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on the strain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aureu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1199B (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A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+++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comparisons between untreated control and the seria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lutio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iprofloxac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one-way ANOVA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 test (* p &lt; 0.05; ** p &lt; 0.01; ***p&lt;0.001 and **** p &lt; 0.000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73190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76672" y="25152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1043608"/>
            <a:ext cx="5683489" cy="2903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88640" y="6876256"/>
            <a:ext cx="63093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effect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rial concentrations of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ofil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vention (BPC) and eradication (BEC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the strain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. aureu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1199B (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or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++).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s between untreated control and the serial dilutions of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one-way ANOVA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 test (* p &lt; 0.05; ** p &lt; 0.01; ***p&lt;0.001 and **** p &lt; 0.000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67966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76672" y="25152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188640" y="7168063"/>
            <a:ext cx="63093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effect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rial concentrations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iprofloxac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ofilm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vention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PC; 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radicatio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C; B) on the strain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aureu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A1199 (wild type, basal expression of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comparisons between untreated control and the serial dilutions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iprofloxac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one-way ANOVA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 test (* p &lt; 0.05; ** p &lt; 0.01; ***p&lt;0.001 and **** p &lt; 0.000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912" y="1115616"/>
            <a:ext cx="6086774" cy="3097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579316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76672" y="25152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5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8381" y="6444208"/>
            <a:ext cx="656897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effect of the combination of ciprofloxacin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iofilm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vention (BPC) and eradication (BE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on the strain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. aureu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A1199 (wild type with basal expression of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rs and whiskers represent the means ±SD of three independent experiments. (A) Biofilm prevention concentration (BPC)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µg/mL ciprofloxacin in combination with increasing concentration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value “0” means treatment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µg/mL ciprofloxacin without additio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B) Biofilm eradication concentration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µg/mL ciprofloxacin in combination with increasing concentration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value “0” means treatment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5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µg/mL ciprofloxacin without additio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s between untreated control and the serial dilution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one-way ANOVA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unnett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 test (* p &lt; 0.05; ** p &lt; 0.01; ***p&lt;0.001 and **** p &lt; 0.000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367" y="899592"/>
            <a:ext cx="6052634" cy="30970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4562742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76672" y="25152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6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 descr="C:\Users\L00527\Desktop\proyecto nuevo\papers\Saskia\Paper antimicrobials\Re submission to frontiers\resubmission\cytotoxicity in edgell cells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827584"/>
            <a:ext cx="3654425" cy="4286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88640" y="6876256"/>
            <a:ext cx="63093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thelial cells (EA.hy926, ATCC CRL-2922) were incubated for 24 hours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lotini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lone or in combination with ciprofloxacin. After 24 hours, the cells  we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ashed, stained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pidiu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odide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cell death was measured by flow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No differences were found by the analysis of ANOVA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15300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1</Words>
  <Application>Microsoft Office PowerPoint</Application>
  <PresentationFormat>Bildschirmpräsentation (4:3)</PresentationFormat>
  <Paragraphs>12</Paragraphs>
  <Slides>6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7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20</cp:revision>
  <cp:lastPrinted>2019-11-04T11:59:04Z</cp:lastPrinted>
  <dcterms:created xsi:type="dcterms:W3CDTF">2019-08-21T06:32:04Z</dcterms:created>
  <dcterms:modified xsi:type="dcterms:W3CDTF">2019-11-18T13:42:04Z</dcterms:modified>
</cp:coreProperties>
</file>